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4" r:id="rId4"/>
    <p:sldId id="26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63" d="100"/>
          <a:sy n="63" d="100"/>
        </p:scale>
        <p:origin x="81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presProps" Target="presProps.xml"/>
   <Relationship Id="rId7" Type="http://schemas.openxmlformats.org/officeDocument/2006/relationships/viewProps" Target="viewProps.xml"/>
   <Relationship Id="rId8" Type="http://schemas.openxmlformats.org/officeDocument/2006/relationships/theme" Target="theme/theme1.xml"/>
   <Relationship Id="rId9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57405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4678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2432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228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0779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7846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7809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2567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8618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5612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5084241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3E0BA-F5C5-4E2E-A1AB-5623CBF8D108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B9ABDD-0B01-40EC-8DF9-38AC083269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9333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   <Relationship Id="rId2" Type="http://schemas.openxmlformats.org/officeDocument/2006/relationships/image" Target="../media/image1.jpg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2.jpg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2972" y="14206"/>
            <a:ext cx="9903602" cy="6843794"/>
          </a:xfrm>
        </p:spPr>
      </p:pic>
      <p:sp>
        <p:nvSpPr>
          <p:cNvPr id="2" name="TextBox 1"/>
          <p:cNvSpPr txBox="1"/>
          <p:nvPr/>
        </p:nvSpPr>
        <p:spPr>
          <a:xfrm>
            <a:off x="7437120" y="853440"/>
            <a:ext cx="1142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β</a:t>
            </a:r>
            <a:r>
              <a:rPr lang="en-US" dirty="0" smtClean="0"/>
              <a:t>-strand 2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4523232" y="3121152"/>
            <a:ext cx="2648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Å</a:t>
            </a:r>
            <a:endParaRPr lang="en-US" sz="1000" dirty="0"/>
          </a:p>
        </p:txBody>
      </p:sp>
      <p:sp>
        <p:nvSpPr>
          <p:cNvPr id="6" name="TextBox 5"/>
          <p:cNvSpPr txBox="1"/>
          <p:nvPr/>
        </p:nvSpPr>
        <p:spPr>
          <a:xfrm>
            <a:off x="4047744" y="2170176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4</a:t>
            </a:r>
            <a:endParaRPr lang="en-US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914144" y="524256"/>
            <a:ext cx="3217547" cy="36933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Wild Type </a:t>
            </a:r>
            <a:r>
              <a:rPr lang="en-US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PfDHPS</a:t>
            </a:r>
            <a:r>
              <a:rPr lang="en-US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 I431</a:t>
            </a:r>
            <a:endParaRPr 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589520" y="1997722"/>
            <a:ext cx="1142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β</a:t>
            </a:r>
            <a:r>
              <a:rPr lang="en-US" dirty="0" smtClean="0"/>
              <a:t>-strand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06883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3920" y="-30996"/>
            <a:ext cx="9924160" cy="6858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523232" y="2852928"/>
            <a:ext cx="2648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Å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1914144" y="524256"/>
            <a:ext cx="2666114" cy="369332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Mutant </a:t>
            </a:r>
            <a:r>
              <a:rPr lang="en-US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PfDHPS</a:t>
            </a:r>
            <a:r>
              <a:rPr lang="en-US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431V</a:t>
            </a:r>
            <a:endParaRPr lang="en-US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664430" y="1917652"/>
            <a:ext cx="1142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β</a:t>
            </a:r>
            <a:r>
              <a:rPr lang="en-US" dirty="0" smtClean="0"/>
              <a:t>-strand 1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7589520" y="788856"/>
            <a:ext cx="1142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β</a:t>
            </a:r>
            <a:r>
              <a:rPr lang="en-US" dirty="0" smtClean="0"/>
              <a:t>-strand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65601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641717"/>
            <a:ext cx="10515600" cy="4351338"/>
          </a:xfrm>
        </p:spPr>
        <p:txBody>
          <a:bodyPr>
            <a:noAutofit/>
          </a:bodyPr>
          <a:lstStyle/>
          <a:p>
            <a:pPr marL="0" indent="0" algn="just">
              <a:lnSpc>
                <a:spcPct val="100000"/>
              </a:lnSpc>
              <a:buNone/>
            </a:pPr>
            <a:r>
              <a:rPr lang="el-GR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β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 and </a:t>
            </a:r>
            <a:r>
              <a:rPr lang="el-GR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β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2 are adjacent parallel strands, H-bonded together by backbone atoms into a rigid </a:t>
            </a:r>
            <a:r>
              <a:rPr lang="el-GR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β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sheet.  In our homology model for the wild-type </a:t>
            </a:r>
            <a:r>
              <a:rPr lang="en-US" sz="24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PfDHPS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component, the side chain of Ile 431 in </a:t>
            </a:r>
            <a:r>
              <a:rPr lang="el-GR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β</a:t>
            </a:r>
            <a:r>
              <a:rPr lang="en-US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-2 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shows hydrophobic interaction (</a:t>
            </a:r>
            <a:r>
              <a:rPr lang="en-US" sz="24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2.763</a:t>
            </a:r>
            <a:r>
              <a:rPr lang="en-US" sz="2400" dirty="0" err="1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Å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) with that of </a:t>
            </a:r>
            <a:r>
              <a:rPr lang="en-US" sz="24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Leu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395 in </a:t>
            </a:r>
            <a:r>
              <a:rPr lang="el-GR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β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1. </a:t>
            </a:r>
          </a:p>
          <a:p>
            <a:pPr marL="0" indent="0" algn="just">
              <a:lnSpc>
                <a:spcPct val="100000"/>
              </a:lnSpc>
              <a:buNone/>
            </a:pP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his strengthens the link between C-terminal ends of these </a:t>
            </a:r>
            <a:r>
              <a:rPr lang="el-GR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β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strands, normally participating in regulating the position of the mutable substrate-binding residues </a:t>
            </a:r>
            <a:r>
              <a:rPr lang="en-US" sz="24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Ser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436 and  Ala 437 in C-terminal loop </a:t>
            </a:r>
            <a:r>
              <a:rPr lang="en-US" sz="24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 The Ile 431 Val change is expected to prevent this inter-strand stabilizing hydrophobic interaction since the closest side-chain approach is </a:t>
            </a:r>
            <a:r>
              <a:rPr lang="en-US" sz="24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4.157</a:t>
            </a:r>
            <a:r>
              <a:rPr lang="en-US" sz="2400" dirty="0" err="1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Å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. This may render the substrate-binding residues in loop </a:t>
            </a:r>
            <a:r>
              <a:rPr lang="en-US" sz="2400" b="1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marginally less stable, enhancing resistance to drug inhibition. </a:t>
            </a:r>
          </a:p>
          <a:p>
            <a:pPr marL="0" indent="0" algn="just">
              <a:lnSpc>
                <a:spcPct val="220000"/>
              </a:lnSpc>
              <a:buNone/>
            </a:pPr>
            <a:endParaRPr lang="en-US" sz="24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79706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103990"/>
            <a:ext cx="10515600" cy="6617651"/>
          </a:xfrm>
        </p:spPr>
        <p:txBody>
          <a:bodyPr>
            <a:noAutofit/>
          </a:bodyPr>
          <a:lstStyle/>
          <a:p>
            <a:pPr marL="0" indent="0">
              <a:lnSpc>
                <a:spcPct val="110000"/>
              </a:lnSpc>
              <a:buNone/>
            </a:pP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here is only one drug-resistance-associated residue change in a </a:t>
            </a:r>
            <a:r>
              <a:rPr lang="el-GR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β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strand in the multiple alignment of </a:t>
            </a:r>
            <a:r>
              <a:rPr lang="en-US" sz="24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Pemble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et al(2010). This position </a:t>
            </a:r>
            <a:r>
              <a:rPr lang="en-US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(which is represented by wild type </a:t>
            </a:r>
            <a:r>
              <a:rPr lang="en-US" sz="24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Leu</a:t>
            </a:r>
            <a:r>
              <a:rPr lang="en-US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 in </a:t>
            </a:r>
            <a:r>
              <a:rPr lang="en-US" sz="24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PfDHPS</a:t>
            </a:r>
            <a:r>
              <a:rPr lang="en-US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) 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s in </a:t>
            </a:r>
            <a:r>
              <a:rPr lang="el-GR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β</a:t>
            </a:r>
            <a:r>
              <a:rPr lang="en-US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strand 4 which is backbone H-bonded to </a:t>
            </a:r>
            <a:r>
              <a:rPr lang="el-GR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β</a:t>
            </a:r>
            <a:r>
              <a:rPr lang="en-US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-strand 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3 as a </a:t>
            </a:r>
            <a:r>
              <a:rPr lang="el-GR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β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-sheet. </a:t>
            </a:r>
          </a:p>
          <a:p>
            <a:pPr marL="0" indent="0">
              <a:lnSpc>
                <a:spcPct val="110000"/>
              </a:lnSpc>
              <a:buNone/>
            </a:pP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This residue precedes a completely-conserved </a:t>
            </a:r>
            <a:r>
              <a:rPr lang="en-US" sz="24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Asn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and Asp, the first of which is a substrate-binding site.</a:t>
            </a:r>
          </a:p>
          <a:p>
            <a:pPr marL="0" indent="0">
              <a:lnSpc>
                <a:spcPct val="110000"/>
              </a:lnSpc>
              <a:buNone/>
            </a:pP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In </a:t>
            </a:r>
            <a:r>
              <a:rPr lang="en-US" sz="24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PfDHPS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, for comparison, Ile 431 in </a:t>
            </a:r>
            <a:r>
              <a:rPr lang="el-GR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β</a:t>
            </a:r>
            <a:r>
              <a:rPr lang="en-US" sz="2400" dirty="0">
                <a:latin typeface="Courier New" panose="02070309020205020404" pitchFamily="49" charset="0"/>
                <a:cs typeface="Courier New" panose="02070309020205020404" pitchFamily="49" charset="0"/>
              </a:rPr>
              <a:t>-strand 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2 immediately follows a completely conserved Asp 430 residue, which is at a substrate-binding site in the alignment, while it is followed by the completely-conserved </a:t>
            </a:r>
            <a:r>
              <a:rPr lang="en-US" sz="24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Gly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432. </a:t>
            </a:r>
          </a:p>
          <a:p>
            <a:pPr marL="0" indent="0">
              <a:lnSpc>
                <a:spcPct val="110000"/>
              </a:lnSpc>
              <a:buNone/>
            </a:pPr>
            <a:endParaRPr lang="en-US" sz="24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 marL="0" indent="0">
              <a:lnSpc>
                <a:spcPct val="110000"/>
              </a:lnSpc>
              <a:buNone/>
            </a:pP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his correspondence with the report of </a:t>
            </a:r>
            <a:r>
              <a:rPr lang="en-US" sz="2400" dirty="0" err="1" smtClean="0">
                <a:latin typeface="Courier New" panose="02070309020205020404" pitchFamily="49" charset="0"/>
                <a:cs typeface="Courier New" panose="02070309020205020404" pitchFamily="49" charset="0"/>
              </a:rPr>
              <a:t>Pemble</a:t>
            </a:r>
            <a:r>
              <a:rPr lang="en-US" sz="24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et al is highly suggestive.   </a:t>
            </a:r>
            <a:endParaRPr lang="en-US" sz="24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581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1</TotalTime>
  <Words>275</Words>
  <Application>Microsoft Office PowerPoint</Application>
  <PresentationFormat>Widescreen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Cambria Math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